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B3F31-2684-425F-8843-AD5039AB38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6E2B1E-F9B4-4607-BE6F-52CB7C6B26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E230CE-5B29-40E4-8B09-916E47C175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69E96-CB8E-4560-BC64-0F49105BE7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22F9D-F769-4D29-933B-ACAE2A375F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5851B3-E024-4DB6-9211-63CC17ACDF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4BE8B5-D0BB-4B17-A550-12783FB161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93265-D1BC-419F-8796-888BBA10F7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5DC673-B65C-40F8-A27F-4AE206434A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D5918-DB46-40CD-8D18-B88F3A03A4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12814-9DA8-4526-9880-3B63AE78E2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B7C01-E2D6-40D4-9AE5-DAB99C3FE2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E22924-DE78-49C9-8917-84CDE59D8A1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4"/>
          <p:cNvSpPr/>
          <p:nvPr/>
        </p:nvSpPr>
        <p:spPr>
          <a:xfrm>
            <a:off x="66600" y="57240"/>
            <a:ext cx="207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35000" y="461880"/>
            <a:ext cx="3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08000" y="2798640"/>
            <a:ext cx="3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860120" y="579600"/>
            <a:ext cx="33912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820520" y="3006720"/>
            <a:ext cx="390960" cy="167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H129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-520920" y="1535760"/>
            <a:ext cx="177768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ng u-PAR/mg total protei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966960" y="1209600"/>
            <a:ext cx="172800" cy="10461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569960" y="1739880"/>
            <a:ext cx="173160" cy="51588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171880" y="1170000"/>
            <a:ext cx="172800" cy="10857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773440" y="1776240"/>
            <a:ext cx="172800" cy="4795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39760" y="1689120"/>
            <a:ext cx="169920" cy="5666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743120" y="1859040"/>
            <a:ext cx="168120" cy="3967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344680" y="1717560"/>
            <a:ext cx="169920" cy="5382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946240" y="1873080"/>
            <a:ext cx="169920" cy="382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1054080" y="1134720"/>
            <a:ext cx="1440" cy="74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042920" y="113508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1655640" y="1649160"/>
            <a:ext cx="1800" cy="90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644480" y="164952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2257560" y="1123920"/>
            <a:ext cx="1440" cy="46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247840" y="1123920"/>
            <a:ext cx="23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2860560" y="1722240"/>
            <a:ext cx="1800" cy="53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849400" y="172260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1224000" y="1589040"/>
            <a:ext cx="1440" cy="100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212840" y="1589040"/>
            <a:ext cx="25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V="1">
            <a:off x="1825560" y="1815840"/>
            <a:ext cx="1800" cy="42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814400" y="1816200"/>
            <a:ext cx="25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V="1">
            <a:off x="2427120" y="1642680"/>
            <a:ext cx="1800" cy="74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416320" y="1643040"/>
            <a:ext cx="252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V="1">
            <a:off x="3029040" y="1829880"/>
            <a:ext cx="1440" cy="42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019320" y="1830240"/>
            <a:ext cx="23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838080" y="979560"/>
            <a:ext cx="1800" cy="1276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822240" y="225576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822240" y="209700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822240" y="193824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822240" y="177624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822240" y="161784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822240" y="145908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822240" y="130032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822240" y="113832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22240" y="97956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838080" y="2255760"/>
            <a:ext cx="24084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838080" y="2255760"/>
            <a:ext cx="180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1440000" y="2255760"/>
            <a:ext cx="144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2041560" y="2255760"/>
            <a:ext cx="144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2643120" y="2255760"/>
            <a:ext cx="180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V="1">
            <a:off x="3246480" y="2255760"/>
            <a:ext cx="144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696600" y="21686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20640" y="20113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544320" y="185256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544320" y="169056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544320" y="153180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44320" y="137304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44320" y="121428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44320" y="105264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44320" y="89388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810360" y="2295360"/>
            <a:ext cx="5706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Times New Roman"/>
              </a:rPr>
              <a:t>Scramb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433520" y="2295360"/>
            <a:ext cx="554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Times New Roman"/>
              </a:rPr>
              <a:t>si-u-PA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073240" y="2295360"/>
            <a:ext cx="482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Times New Roman"/>
              </a:rPr>
              <a:t>sh-RN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621880" y="2295360"/>
            <a:ext cx="5922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Times New Roman"/>
              </a:rPr>
              <a:t>sh-u-PA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" name=""/>
          <p:cNvGrpSpPr/>
          <p:nvPr/>
        </p:nvGrpSpPr>
        <p:grpSpPr>
          <a:xfrm>
            <a:off x="2593800" y="1197000"/>
            <a:ext cx="504720" cy="277920"/>
            <a:chOff x="2593800" y="1197000"/>
            <a:chExt cx="504720" cy="277920"/>
          </a:xfrm>
        </p:grpSpPr>
        <p:sp>
          <p:nvSpPr>
            <p:cNvPr id="101" name=""/>
            <p:cNvSpPr/>
            <p:nvPr/>
          </p:nvSpPr>
          <p:spPr>
            <a:xfrm>
              <a:off x="2593800" y="1197000"/>
              <a:ext cx="504720" cy="27792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H="1">
              <a:off x="2641320" y="1260720"/>
              <a:ext cx="36720" cy="36360"/>
            </a:xfrm>
            <a:prstGeom prst="rect">
              <a:avLst/>
            </a:prstGeom>
            <a:solidFill>
              <a:srgbClr val="ffffff"/>
            </a:solidFill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723400" y="1225800"/>
              <a:ext cx="30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DMS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728080" y="1336680"/>
              <a:ext cx="171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Enz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H="1">
              <a:off x="2641320" y="1384560"/>
              <a:ext cx="36720" cy="36360"/>
            </a:xfrm>
            <a:prstGeom prst="rect">
              <a:avLst/>
            </a:prstGeom>
            <a:solidFill>
              <a:srgbClr val="000000"/>
            </a:solidFill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6" name=""/>
          <p:cNvSpPr/>
          <p:nvPr/>
        </p:nvSpPr>
        <p:spPr>
          <a:xfrm>
            <a:off x="960480" y="3770280"/>
            <a:ext cx="176040" cy="10065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569960" y="4376880"/>
            <a:ext cx="176400" cy="3999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182680" y="3691080"/>
            <a:ext cx="176400" cy="10857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790720" y="4351320"/>
            <a:ext cx="176400" cy="4255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136520" y="4260960"/>
            <a:ext cx="173160" cy="5158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746360" y="4487760"/>
            <a:ext cx="174600" cy="2890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359080" y="4286160"/>
            <a:ext cx="171360" cy="490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967120" y="4498920"/>
            <a:ext cx="172800" cy="277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flipV="1">
            <a:off x="1047600" y="3704760"/>
            <a:ext cx="1800" cy="65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038240" y="3705120"/>
            <a:ext cx="23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flipV="1">
            <a:off x="1657440" y="4346640"/>
            <a:ext cx="1440" cy="30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647720" y="4346640"/>
            <a:ext cx="223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 flipV="1">
            <a:off x="2270160" y="3619080"/>
            <a:ext cx="1440" cy="71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260440" y="3619440"/>
            <a:ext cx="22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flipV="1">
            <a:off x="2879640" y="4300200"/>
            <a:ext cx="1800" cy="50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870280" y="4300560"/>
            <a:ext cx="223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V="1">
            <a:off x="1220760" y="4178160"/>
            <a:ext cx="1440" cy="82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211400" y="4178160"/>
            <a:ext cx="219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1833480" y="4456080"/>
            <a:ext cx="1800" cy="31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824120" y="4456080"/>
            <a:ext cx="22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flipV="1">
            <a:off x="2443320" y="4217760"/>
            <a:ext cx="1440" cy="68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433600" y="4218120"/>
            <a:ext cx="223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3052800" y="4455720"/>
            <a:ext cx="1440" cy="42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043080" y="4456080"/>
            <a:ext cx="22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830160" y="3500280"/>
            <a:ext cx="1800" cy="1276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817560" y="4776840"/>
            <a:ext cx="126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817560" y="4635360"/>
            <a:ext cx="126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817560" y="4491000"/>
            <a:ext cx="126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817560" y="4351320"/>
            <a:ext cx="126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817560" y="4210200"/>
            <a:ext cx="126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817560" y="4065480"/>
            <a:ext cx="126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817560" y="3925800"/>
            <a:ext cx="126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817560" y="3784680"/>
            <a:ext cx="126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817560" y="3641760"/>
            <a:ext cx="126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817560" y="3500280"/>
            <a:ext cx="126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830160" y="4776840"/>
            <a:ext cx="2440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flipV="1">
            <a:off x="830160" y="4776840"/>
            <a:ext cx="180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V="1">
            <a:off x="1440000" y="4776840"/>
            <a:ext cx="144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flipV="1">
            <a:off x="2052720" y="4776840"/>
            <a:ext cx="144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V="1">
            <a:off x="2660760" y="4776840"/>
            <a:ext cx="144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flipV="1">
            <a:off x="3270240" y="4776840"/>
            <a:ext cx="144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720360" y="46990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568080" y="455940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568080" y="441468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568080" y="427500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568080" y="413388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491760" y="3989520"/>
            <a:ext cx="305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91760" y="3849840"/>
            <a:ext cx="305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491760" y="3708360"/>
            <a:ext cx="305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491760" y="3564000"/>
            <a:ext cx="305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91760" y="3424320"/>
            <a:ext cx="305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835560" y="4816440"/>
            <a:ext cx="5706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Times New Roman"/>
              </a:rPr>
              <a:t>Scramb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455840" y="4816440"/>
            <a:ext cx="554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Times New Roman"/>
              </a:rPr>
              <a:t>si-u-PA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073240" y="4816440"/>
            <a:ext cx="482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Times New Roman"/>
              </a:rPr>
              <a:t>sh-RN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2650320" y="4816440"/>
            <a:ext cx="5922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Times New Roman"/>
              </a:rPr>
              <a:t>sh-u-PA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rot="16200000">
            <a:off x="-534960" y="4172400"/>
            <a:ext cx="177768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ng u-PAR/mg total protei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2" name=""/>
          <p:cNvGrpSpPr/>
          <p:nvPr/>
        </p:nvGrpSpPr>
        <p:grpSpPr>
          <a:xfrm>
            <a:off x="2593800" y="3511440"/>
            <a:ext cx="504720" cy="277920"/>
            <a:chOff x="2593800" y="3511440"/>
            <a:chExt cx="504720" cy="277920"/>
          </a:xfrm>
        </p:grpSpPr>
        <p:sp>
          <p:nvSpPr>
            <p:cNvPr id="163" name=""/>
            <p:cNvSpPr/>
            <p:nvPr/>
          </p:nvSpPr>
          <p:spPr>
            <a:xfrm>
              <a:off x="2593800" y="3511440"/>
              <a:ext cx="504720" cy="27792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flipH="1">
              <a:off x="2641320" y="3575160"/>
              <a:ext cx="36720" cy="36360"/>
            </a:xfrm>
            <a:prstGeom prst="rect">
              <a:avLst/>
            </a:prstGeom>
            <a:solidFill>
              <a:srgbClr val="ffffff"/>
            </a:solidFill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723400" y="3540240"/>
              <a:ext cx="30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DMS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2728080" y="3651120"/>
              <a:ext cx="171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Enz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 flipH="1">
              <a:off x="2641320" y="3699000"/>
              <a:ext cx="36720" cy="36360"/>
            </a:xfrm>
            <a:prstGeom prst="rect">
              <a:avLst/>
            </a:prstGeom>
            <a:solidFill>
              <a:srgbClr val="000000"/>
            </a:solidFill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3T11:42:16Z</dcterms:created>
  <dc:creator>Mudduluru</dc:creator>
  <dc:description/>
  <dc:language>en-US</dc:language>
  <cp:lastModifiedBy>mudduluru</cp:lastModifiedBy>
  <dcterms:modified xsi:type="dcterms:W3CDTF">2010-05-03T10:16:57Z</dcterms:modified>
  <cp:revision>107</cp:revision>
  <dc:subject/>
  <dc:title>Folie 1</dc:title>
</cp:coreProperties>
</file>